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6" r:id="rId3"/>
    <p:sldId id="257" r:id="rId4"/>
    <p:sldId id="258" r:id="rId5"/>
    <p:sldId id="26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91" d="100"/>
          <a:sy n="91" d="100"/>
        </p:scale>
        <p:origin x="28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6030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0992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8092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8794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2790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210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52721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7135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835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87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619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72E5C3-8951-43EE-9AFA-362B8572B9E6}" type="datetimeFigureOut">
              <a:rPr kumimoji="1" lang="ja-JP" altLang="en-US" smtClean="0"/>
              <a:t>2021/9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B54E79-52E2-4243-9944-28EC9A53D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371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24BF5C1-54E8-4D43-8672-177EEE081BA9}"/>
              </a:ext>
            </a:extLst>
          </p:cNvPr>
          <p:cNvSpPr txBox="1"/>
          <p:nvPr/>
        </p:nvSpPr>
        <p:spPr>
          <a:xfrm>
            <a:off x="695528" y="700392"/>
            <a:ext cx="5466944" cy="54990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dirty="0">
                <a:latin typeface="Arial" panose="020B0604020202020204" pitchFamily="34" charset="0"/>
                <a:ea typeface="TakaoPGothic"/>
                <a:cs typeface="TakaoPGothic"/>
              </a:rPr>
              <a:t>Mating system evolution and genetic structure of diploid sexual </a:t>
            </a:r>
            <a:r>
              <a:rPr lang="en-US" altLang="ja-JP" dirty="0">
                <a:latin typeface="Arial" panose="020B0604020202020204" pitchFamily="34" charset="0"/>
                <a:ea typeface="ＭＳ 明朝" panose="02020609040205080304" pitchFamily="17" charset="-128"/>
                <a:cs typeface="TakaoPGothic"/>
              </a:rPr>
              <a:t>populations of </a:t>
            </a:r>
            <a:r>
              <a:rPr lang="en-US" altLang="ja-JP" i="1" dirty="0" err="1">
                <a:latin typeface="Arial" panose="020B0604020202020204" pitchFamily="34" charset="0"/>
                <a:ea typeface="TakaoPGothic"/>
                <a:cs typeface="TakaoPGothic"/>
              </a:rPr>
              <a:t>Cyrtomium</a:t>
            </a:r>
            <a:r>
              <a:rPr lang="en-US" altLang="ja-JP" i="1" dirty="0">
                <a:latin typeface="Arial" panose="020B0604020202020204" pitchFamily="34" charset="0"/>
                <a:ea typeface="TakaoPGothic"/>
                <a:cs typeface="TakaoPGothic"/>
              </a:rPr>
              <a:t> </a:t>
            </a:r>
            <a:r>
              <a:rPr lang="en-US" altLang="ja-JP" i="1" dirty="0" err="1">
                <a:latin typeface="Arial" panose="020B0604020202020204" pitchFamily="34" charset="0"/>
                <a:ea typeface="TakaoPGothic"/>
                <a:cs typeface="TakaoPGothic"/>
              </a:rPr>
              <a:t>falcatum</a:t>
            </a:r>
            <a:r>
              <a:rPr lang="en-US" altLang="ja-JP" dirty="0">
                <a:latin typeface="Arial" panose="020B0604020202020204" pitchFamily="34" charset="0"/>
                <a:ea typeface="TakaoPGothic"/>
                <a:cs typeface="TakaoPGothic"/>
              </a:rPr>
              <a:t> in Japan</a:t>
            </a:r>
            <a:endParaRPr lang="ja-JP" altLang="ja-JP" sz="1400" dirty="0">
              <a:latin typeface="Liberation Serif"/>
              <a:ea typeface="TakaoPGothic"/>
              <a:cs typeface="TakaoPGothic"/>
            </a:endParaRPr>
          </a:p>
          <a:p>
            <a:pPr>
              <a:lnSpc>
                <a:spcPts val="2400"/>
              </a:lnSpc>
              <a:spcAft>
                <a:spcPts val="0"/>
              </a:spcAft>
            </a:pPr>
            <a:r>
              <a:rPr lang="en-US" altLang="ja-JP" sz="1600" dirty="0">
                <a:latin typeface="Times New Roman" panose="02020603050405020304" pitchFamily="18" charset="0"/>
                <a:ea typeface="ＭＳ 明朝" panose="02020609040205080304" pitchFamily="17" charset="-128"/>
                <a:cs typeface="TakaoPGothic"/>
              </a:rPr>
              <a:t> </a:t>
            </a:r>
            <a:endParaRPr lang="ja-JP" altLang="ja-JP" sz="1600" dirty="0">
              <a:latin typeface="Liberation Serif"/>
              <a:ea typeface="TakaoPGothic"/>
              <a:cs typeface="TakaoPGothic"/>
            </a:endParaRPr>
          </a:p>
          <a:p>
            <a:pPr>
              <a:lnSpc>
                <a:spcPts val="2400"/>
              </a:lnSpc>
              <a:spcAft>
                <a:spcPts val="0"/>
              </a:spcAft>
            </a:pPr>
            <a:r>
              <a:rPr lang="en-US" altLang="ja-JP" sz="1400" dirty="0">
                <a:latin typeface="Times New Roman" panose="02020603050405020304" pitchFamily="18" charset="0"/>
                <a:ea typeface="TakaoPGothic"/>
                <a:cs typeface="TakaoPGothic"/>
              </a:rPr>
              <a:t>Ryosuke Imai</a:t>
            </a:r>
            <a:r>
              <a:rPr lang="en-US" altLang="ja-JP" sz="1400" baseline="30000" dirty="0">
                <a:latin typeface="Times New Roman" panose="02020603050405020304" pitchFamily="18" charset="0"/>
                <a:ea typeface="TakaoPGothic"/>
                <a:cs typeface="TakaoPGothic"/>
              </a:rPr>
              <a:t>1*#</a:t>
            </a:r>
            <a:r>
              <a:rPr lang="en-US" altLang="ja-JP" sz="1400" dirty="0">
                <a:latin typeface="Times New Roman" panose="02020603050405020304" pitchFamily="18" charset="0"/>
                <a:ea typeface="TakaoPGothic"/>
                <a:cs typeface="TakaoPGothic"/>
              </a:rPr>
              <a:t>, Yoshiaki Tsuda</a:t>
            </a:r>
            <a:r>
              <a:rPr lang="en-US" altLang="ja-JP" sz="1400" baseline="30000" dirty="0">
                <a:latin typeface="Times New Roman" panose="02020603050405020304" pitchFamily="18" charset="0"/>
                <a:ea typeface="TakaoPGothic"/>
                <a:cs typeface="TakaoPGothic"/>
              </a:rPr>
              <a:t>1*</a:t>
            </a:r>
            <a:r>
              <a:rPr lang="en-US" altLang="ja-JP" sz="1400" dirty="0">
                <a:latin typeface="Times New Roman" panose="02020603050405020304" pitchFamily="18" charset="0"/>
                <a:ea typeface="TakaoPGothic"/>
                <a:cs typeface="TakaoPGothic"/>
              </a:rPr>
              <a:t>, Atsushi Ebihara</a:t>
            </a:r>
            <a:r>
              <a:rPr lang="en-US" altLang="ja-JP" sz="1400" baseline="30000" dirty="0">
                <a:latin typeface="Times New Roman" panose="02020603050405020304" pitchFamily="18" charset="0"/>
                <a:ea typeface="TakaoPGothic"/>
                <a:cs typeface="TakaoPGothic"/>
              </a:rPr>
              <a:t>2</a:t>
            </a:r>
            <a:r>
              <a:rPr lang="en-US" altLang="ja-JP" sz="1400" dirty="0">
                <a:latin typeface="Times New Roman" panose="02020603050405020304" pitchFamily="18" charset="0"/>
                <a:ea typeface="TakaoPGothic"/>
                <a:cs typeface="TakaoPGothic"/>
              </a:rPr>
              <a:t>, </a:t>
            </a:r>
            <a:r>
              <a:rPr lang="en-US" altLang="ja-JP" sz="1400" dirty="0" err="1">
                <a:latin typeface="Times New Roman" panose="02020603050405020304" pitchFamily="18" charset="0"/>
                <a:ea typeface="TakaoPGothic"/>
                <a:cs typeface="TakaoPGothic"/>
              </a:rPr>
              <a:t>Sadamu</a:t>
            </a:r>
            <a:r>
              <a:rPr lang="en-US" altLang="ja-JP" sz="1400" dirty="0">
                <a:latin typeface="Times New Roman" panose="02020603050405020304" pitchFamily="18" charset="0"/>
                <a:ea typeface="TakaoPGothic"/>
                <a:cs typeface="TakaoPGothic"/>
              </a:rPr>
              <a:t> Matsumoto</a:t>
            </a:r>
            <a:r>
              <a:rPr lang="en-US" altLang="ja-JP" sz="1400" baseline="30000" dirty="0">
                <a:latin typeface="Times New Roman" panose="02020603050405020304" pitchFamily="18" charset="0"/>
                <a:ea typeface="TakaoPGothic"/>
                <a:cs typeface="TakaoPGothic"/>
              </a:rPr>
              <a:t>2</a:t>
            </a:r>
            <a:r>
              <a:rPr lang="en-US" altLang="ja-JP" sz="1400" dirty="0">
                <a:latin typeface="Times New Roman" panose="02020603050405020304" pitchFamily="18" charset="0"/>
                <a:ea typeface="TakaoPGothic"/>
                <a:cs typeface="TakaoPGothic"/>
              </a:rPr>
              <a:t>, </a:t>
            </a:r>
            <a:r>
              <a:rPr lang="en-US" altLang="ja-JP" sz="1400" dirty="0" err="1">
                <a:latin typeface="Times New Roman" panose="02020603050405020304" pitchFamily="18" charset="0"/>
                <a:ea typeface="TakaoPGothic"/>
                <a:cs typeface="TakaoPGothic"/>
              </a:rPr>
              <a:t>Ayumi</a:t>
            </a:r>
            <a:r>
              <a:rPr lang="en-US" altLang="ja-JP" sz="1400" dirty="0">
                <a:latin typeface="Times New Roman" panose="02020603050405020304" pitchFamily="18" charset="0"/>
                <a:ea typeface="TakaoPGothic"/>
                <a:cs typeface="TakaoPGothic"/>
              </a:rPr>
              <a:t> Tezuka</a:t>
            </a:r>
            <a:r>
              <a:rPr lang="en-US" altLang="ja-JP" sz="1400" baseline="30000" dirty="0">
                <a:latin typeface="Times New Roman" panose="02020603050405020304" pitchFamily="18" charset="0"/>
                <a:ea typeface="TakaoPGothic"/>
                <a:cs typeface="TakaoPGothic"/>
              </a:rPr>
              <a:t>3</a:t>
            </a:r>
            <a:r>
              <a:rPr lang="en-US" altLang="ja-JP" sz="1400" dirty="0">
                <a:latin typeface="Times New Roman" panose="02020603050405020304" pitchFamily="18" charset="0"/>
                <a:ea typeface="TakaoPGothic"/>
                <a:cs typeface="TakaoPGothic"/>
              </a:rPr>
              <a:t>, Atsushi J. Nagano</a:t>
            </a:r>
            <a:r>
              <a:rPr lang="en-US" altLang="ja-JP" sz="1400" baseline="30000" dirty="0">
                <a:latin typeface="Times New Roman" panose="02020603050405020304" pitchFamily="18" charset="0"/>
                <a:ea typeface="TakaoPGothic"/>
                <a:cs typeface="TakaoPGothic"/>
              </a:rPr>
              <a:t>3</a:t>
            </a:r>
            <a:r>
              <a:rPr lang="en-US" altLang="ja-JP" sz="1400" dirty="0">
                <a:latin typeface="Times New Roman" panose="02020603050405020304" pitchFamily="18" charset="0"/>
                <a:ea typeface="TakaoPGothic"/>
                <a:cs typeface="TakaoPGothic"/>
              </a:rPr>
              <a:t>, Ryo Ootsuki</a:t>
            </a:r>
            <a:r>
              <a:rPr lang="en-US" altLang="ja-JP" sz="1400" baseline="30000" dirty="0">
                <a:latin typeface="Times New Roman" panose="02020603050405020304" pitchFamily="18" charset="0"/>
                <a:ea typeface="TakaoPGothic"/>
                <a:cs typeface="TakaoPGothic"/>
              </a:rPr>
              <a:t>4</a:t>
            </a:r>
            <a:r>
              <a:rPr lang="en-US" altLang="ja-JP" sz="1400" dirty="0">
                <a:latin typeface="Times New Roman" panose="02020603050405020304" pitchFamily="18" charset="0"/>
                <a:ea typeface="TakaoPGothic"/>
                <a:cs typeface="TakaoPGothic"/>
              </a:rPr>
              <a:t>, </a:t>
            </a:r>
            <a:r>
              <a:rPr lang="en-US" altLang="ja-JP" sz="1400" dirty="0" err="1">
                <a:latin typeface="Times New Roman" panose="02020603050405020304" pitchFamily="18" charset="0"/>
                <a:ea typeface="TakaoPGothic"/>
                <a:cs typeface="TakaoPGothic"/>
              </a:rPr>
              <a:t>Yasuyuki</a:t>
            </a:r>
            <a:r>
              <a:rPr lang="en-US" altLang="ja-JP" sz="1400" dirty="0">
                <a:latin typeface="Times New Roman" panose="02020603050405020304" pitchFamily="18" charset="0"/>
                <a:ea typeface="TakaoPGothic"/>
                <a:cs typeface="TakaoPGothic"/>
              </a:rPr>
              <a:t> Watano</a:t>
            </a:r>
            <a:r>
              <a:rPr lang="en-US" altLang="ja-JP" sz="1400" baseline="30000" dirty="0">
                <a:latin typeface="Times New Roman" panose="02020603050405020304" pitchFamily="18" charset="0"/>
                <a:ea typeface="TakaoPGothic"/>
                <a:cs typeface="TakaoPGothic"/>
              </a:rPr>
              <a:t>5#</a:t>
            </a:r>
            <a:endParaRPr lang="ja-JP" altLang="ja-JP" sz="1200" dirty="0">
              <a:latin typeface="Liberation Serif"/>
              <a:ea typeface="TakaoPGothic"/>
              <a:cs typeface="TakaoPGothic"/>
            </a:endParaRPr>
          </a:p>
          <a:p>
            <a:pPr>
              <a:lnSpc>
                <a:spcPts val="2400"/>
              </a:lnSpc>
              <a:spcAft>
                <a:spcPts val="0"/>
              </a:spcAft>
            </a:pPr>
            <a:r>
              <a:rPr lang="en-US" altLang="ja-JP" sz="1200" dirty="0">
                <a:latin typeface="Times New Roman" panose="02020603050405020304" pitchFamily="18" charset="0"/>
                <a:ea typeface="TakaoPGothic"/>
                <a:cs typeface="TakaoPGothic"/>
              </a:rPr>
              <a:t>1. </a:t>
            </a:r>
            <a:r>
              <a:rPr lang="en-US" altLang="ja-JP" sz="1200" dirty="0" err="1">
                <a:latin typeface="Times New Roman" panose="02020603050405020304" pitchFamily="18" charset="0"/>
                <a:ea typeface="TakaoPGothic"/>
                <a:cs typeface="TakaoPGothic"/>
              </a:rPr>
              <a:t>Sugadaira</a:t>
            </a:r>
            <a:r>
              <a:rPr lang="en-US" altLang="ja-JP" sz="1200" dirty="0">
                <a:latin typeface="Times New Roman" panose="02020603050405020304" pitchFamily="18" charset="0"/>
                <a:ea typeface="TakaoPGothic"/>
                <a:cs typeface="TakaoPGothic"/>
              </a:rPr>
              <a:t> Research Station, Mountain Science Center, University of Tsukuba, </a:t>
            </a:r>
            <a:r>
              <a:rPr lang="en-US" altLang="ja-JP" sz="1200" dirty="0" err="1">
                <a:latin typeface="Times New Roman" panose="02020603050405020304" pitchFamily="18" charset="0"/>
                <a:ea typeface="TakaoPGothic"/>
                <a:cs typeface="TakaoPGothic"/>
              </a:rPr>
              <a:t>Sugadaira</a:t>
            </a:r>
            <a:r>
              <a:rPr lang="en-US" altLang="ja-JP" sz="1200" dirty="0">
                <a:latin typeface="Times New Roman" panose="02020603050405020304" pitchFamily="18" charset="0"/>
                <a:ea typeface="TakaoPGothic"/>
                <a:cs typeface="TakaoPGothic"/>
              </a:rPr>
              <a:t>, Ueda, Nagano, 386-2204 Japan</a:t>
            </a:r>
            <a:endParaRPr lang="ja-JP" altLang="ja-JP" sz="1200" dirty="0">
              <a:latin typeface="Liberation Serif"/>
              <a:ea typeface="TakaoPGothic"/>
              <a:cs typeface="TakaoPGothic"/>
            </a:endParaRPr>
          </a:p>
          <a:p>
            <a:pPr>
              <a:lnSpc>
                <a:spcPts val="2400"/>
              </a:lnSpc>
              <a:spcAft>
                <a:spcPts val="0"/>
              </a:spcAft>
            </a:pPr>
            <a:r>
              <a:rPr lang="en-US" altLang="ja-JP" sz="1200" dirty="0">
                <a:latin typeface="Times New Roman" panose="02020603050405020304" pitchFamily="18" charset="0"/>
                <a:ea typeface="TakaoPGothic"/>
                <a:cs typeface="TakaoPGothic"/>
              </a:rPr>
              <a:t>2. Department of Botany, National Museum of Nature and Science, Tsukuba, Ibaraki, 305-0005, Japan</a:t>
            </a:r>
            <a:endParaRPr lang="ja-JP" altLang="ja-JP" sz="1200" dirty="0">
              <a:latin typeface="Liberation Serif"/>
              <a:ea typeface="TakaoPGothic"/>
              <a:cs typeface="TakaoPGothic"/>
            </a:endParaRPr>
          </a:p>
          <a:p>
            <a:pPr>
              <a:lnSpc>
                <a:spcPts val="2400"/>
              </a:lnSpc>
              <a:spcAft>
                <a:spcPts val="0"/>
              </a:spcAft>
            </a:pPr>
            <a:r>
              <a:rPr lang="en-US" altLang="ja-JP" sz="1200" dirty="0">
                <a:latin typeface="Times New Roman" panose="02020603050405020304" pitchFamily="18" charset="0"/>
                <a:ea typeface="TakaoPGothic"/>
                <a:cs typeface="TakaoPGothic"/>
              </a:rPr>
              <a:t>3. Faculty of Agriculture, </a:t>
            </a:r>
            <a:r>
              <a:rPr lang="en-US" altLang="ja-JP" sz="1200" dirty="0" err="1">
                <a:latin typeface="Times New Roman" panose="02020603050405020304" pitchFamily="18" charset="0"/>
                <a:ea typeface="TakaoPGothic"/>
                <a:cs typeface="TakaoPGothic"/>
              </a:rPr>
              <a:t>Ryukoku</a:t>
            </a:r>
            <a:r>
              <a:rPr lang="en-US" altLang="ja-JP" sz="1200" dirty="0">
                <a:latin typeface="Times New Roman" panose="02020603050405020304" pitchFamily="18" charset="0"/>
                <a:ea typeface="TakaoPGothic"/>
                <a:cs typeface="TakaoPGothic"/>
              </a:rPr>
              <a:t> University, Otsu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akaoPGothic"/>
              </a:rPr>
              <a:t>, Shiga, 520-2194</a:t>
            </a:r>
            <a:r>
              <a:rPr lang="en-US" altLang="ja-JP" sz="1200" dirty="0">
                <a:latin typeface="Times New Roman" panose="02020603050405020304" pitchFamily="18" charset="0"/>
                <a:ea typeface="TakaoPGothic"/>
                <a:cs typeface="TakaoPGothic"/>
              </a:rPr>
              <a:t> Japan</a:t>
            </a:r>
            <a:endParaRPr lang="ja-JP" altLang="ja-JP" sz="1200" dirty="0">
              <a:latin typeface="Liberation Serif"/>
              <a:ea typeface="TakaoPGothic"/>
              <a:cs typeface="TakaoPGothic"/>
            </a:endParaRPr>
          </a:p>
          <a:p>
            <a:pPr>
              <a:lnSpc>
                <a:spcPts val="2400"/>
              </a:lnSpc>
              <a:spcAft>
                <a:spcPts val="0"/>
              </a:spcAft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akaoPGothic"/>
              </a:rPr>
              <a:t>4.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akaoPGothic"/>
              </a:rPr>
              <a:t>Komazaw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akaoPGothic"/>
              </a:rPr>
              <a:t> University Faculty of Arts and Sciences Department of Natural Sciences 1-23-1 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akaoPGothic"/>
              </a:rPr>
              <a:t>Komazawa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akaoPGothic"/>
              </a:rPr>
              <a:t>, Setagaya-</a:t>
            </a:r>
            <a:r>
              <a:rPr lang="en-US" altLang="ja-JP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akaoPGothic"/>
              </a:rPr>
              <a:t>ku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akaoPGothic"/>
              </a:rPr>
              <a:t>, Tokyo,154-8525, Japan</a:t>
            </a:r>
            <a:endParaRPr lang="ja-JP" altLang="ja-JP" sz="1200" dirty="0">
              <a:latin typeface="Liberation Serif"/>
              <a:ea typeface="TakaoPGothic"/>
              <a:cs typeface="TakaoPGothic"/>
            </a:endParaRPr>
          </a:p>
          <a:p>
            <a:pPr>
              <a:lnSpc>
                <a:spcPts val="2400"/>
              </a:lnSpc>
              <a:spcAft>
                <a:spcPts val="0"/>
              </a:spcAft>
            </a:pPr>
            <a:r>
              <a:rPr lang="en-US" altLang="ja-JP" sz="1200" dirty="0">
                <a:latin typeface="Times New Roman" panose="02020603050405020304" pitchFamily="18" charset="0"/>
                <a:ea typeface="TakaoPGothic"/>
                <a:cs typeface="TakaoPGothic"/>
              </a:rPr>
              <a:t>5. Department of Biology, Graduate School of Science, Chiba University, Inage, Chiba, Chiba, 263-8522 Japan</a:t>
            </a:r>
          </a:p>
          <a:p>
            <a:pPr>
              <a:lnSpc>
                <a:spcPts val="2400"/>
              </a:lnSpc>
              <a:spcAft>
                <a:spcPts val="0"/>
              </a:spcAft>
            </a:pPr>
            <a:r>
              <a:rPr lang="en-US" altLang="ja-JP" sz="1200">
                <a:latin typeface="Times New Roman" panose="02020603050405020304" pitchFamily="18" charset="0"/>
                <a:ea typeface="TakaoPGothic"/>
                <a:cs typeface="TakaoPGothic"/>
              </a:rPr>
              <a:t>* Equally </a:t>
            </a:r>
            <a:r>
              <a:rPr lang="en-US" altLang="ja-JP" sz="1200" dirty="0">
                <a:latin typeface="Times New Roman" panose="02020603050405020304" pitchFamily="18" charset="0"/>
                <a:ea typeface="TakaoPGothic"/>
                <a:cs typeface="TakaoPGothic"/>
              </a:rPr>
              <a:t>contributed to this work</a:t>
            </a:r>
          </a:p>
          <a:p>
            <a:pPr>
              <a:lnSpc>
                <a:spcPts val="2400"/>
              </a:lnSpc>
              <a:spcAft>
                <a:spcPts val="0"/>
              </a:spcAft>
            </a:pPr>
            <a:r>
              <a:rPr lang="en-US" altLang="ja-JP" sz="1200" dirty="0">
                <a:latin typeface="Liberation Serif"/>
                <a:ea typeface="TakaoPGothic"/>
                <a:cs typeface="TakaoPGothic"/>
              </a:rPr>
              <a:t># Corresponding author</a:t>
            </a:r>
            <a:endParaRPr lang="ja-JP" altLang="ja-JP" sz="1200" dirty="0">
              <a:latin typeface="Liberation Serif"/>
              <a:ea typeface="TakaoPGothic"/>
              <a:cs typeface="TakaoPGothic"/>
            </a:endParaRPr>
          </a:p>
        </p:txBody>
      </p:sp>
    </p:spTree>
    <p:extLst>
      <p:ext uri="{BB962C8B-B14F-4D97-AF65-F5344CB8AC3E}">
        <p14:creationId xmlns:p14="http://schemas.microsoft.com/office/powerpoint/2010/main" val="30106486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 descr="光 が含まれている画像&#10;&#10;自動的に生成された説明">
            <a:extLst>
              <a:ext uri="{FF2B5EF4-FFF2-40B4-BE49-F238E27FC236}">
                <a16:creationId xmlns:a16="http://schemas.microsoft.com/office/drawing/2014/main" id="{501C1266-47DF-4989-BF40-FA9ED25ABC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9443" y="891549"/>
            <a:ext cx="4639113" cy="3494349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6E50212-5D14-4241-AAEA-1CE4541A0E8E}"/>
              </a:ext>
            </a:extLst>
          </p:cNvPr>
          <p:cNvSpPr txBox="1"/>
          <p:nvPr/>
        </p:nvSpPr>
        <p:spPr>
          <a:xfrm>
            <a:off x="798648" y="5612860"/>
            <a:ext cx="526070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 S1 Haplotype network of C.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falcatum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ubsp.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australe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C.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falcatum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subsp.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littorale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ach number indicate sample size that have respective haplotype. Hap7 was observed in gametophyte sample that is not included in population genetic analysis.</a:t>
            </a:r>
          </a:p>
        </p:txBody>
      </p:sp>
    </p:spTree>
    <p:extLst>
      <p:ext uri="{BB962C8B-B14F-4D97-AF65-F5344CB8AC3E}">
        <p14:creationId xmlns:p14="http://schemas.microsoft.com/office/powerpoint/2010/main" val="2497051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457C0D46-F6F1-49C8-976A-083A577E2D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095" y="685130"/>
            <a:ext cx="4953810" cy="3692317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3D5AD07-3649-4BDB-B01B-9A28E77142D7}"/>
              </a:ext>
            </a:extLst>
          </p:cNvPr>
          <p:cNvSpPr txBox="1"/>
          <p:nvPr/>
        </p:nvSpPr>
        <p:spPr>
          <a:xfrm>
            <a:off x="952095" y="4722167"/>
            <a:ext cx="51303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Figure S2 Posterior probability of the result of Structure analysis in each </a:t>
            </a:r>
            <a:r>
              <a:rPr lang="en-US" altLang="ja-JP" sz="1200" i="1" dirty="0"/>
              <a:t>K</a:t>
            </a:r>
            <a:r>
              <a:rPr lang="en-US" altLang="ja-JP" sz="1200" dirty="0"/>
              <a:t> value</a:t>
            </a:r>
            <a:endParaRPr lang="ja-JP" altLang="ja-JP" sz="1200" dirty="0"/>
          </a:p>
          <a:p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2949190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スクリーンショット が含まれている画像&#10;&#10;自動的に生成された説明">
            <a:extLst>
              <a:ext uri="{FF2B5EF4-FFF2-40B4-BE49-F238E27FC236}">
                <a16:creationId xmlns:a16="http://schemas.microsoft.com/office/drawing/2014/main" id="{C9E33BEE-9506-449F-BB38-3BA6F71455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574" y="543726"/>
            <a:ext cx="5398851" cy="4047560"/>
          </a:xfrm>
          <a:prstGeom prst="rect">
            <a:avLst/>
          </a:prstGeom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1976987-34CE-455C-8D36-22D070542712}"/>
              </a:ext>
            </a:extLst>
          </p:cNvPr>
          <p:cNvSpPr/>
          <p:nvPr/>
        </p:nvSpPr>
        <p:spPr>
          <a:xfrm>
            <a:off x="729574" y="4814500"/>
            <a:ext cx="416343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/>
              <a:t>Figure S3 The values of ΔK of each K value in Structure analysis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2438883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0505768D-6CFE-48D3-8F27-352E98BC78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3863672"/>
              </p:ext>
            </p:extLst>
          </p:nvPr>
        </p:nvGraphicFramePr>
        <p:xfrm>
          <a:off x="333020" y="784849"/>
          <a:ext cx="6191959" cy="3806596"/>
        </p:xfrm>
        <a:graphic>
          <a:graphicData uri="http://schemas.openxmlformats.org/drawingml/2006/table">
            <a:tbl>
              <a:tblPr/>
              <a:tblGrid>
                <a:gridCol w="558459">
                  <a:extLst>
                    <a:ext uri="{9D8B030D-6E8A-4147-A177-3AD203B41FA5}">
                      <a16:colId xmlns:a16="http://schemas.microsoft.com/office/drawing/2014/main" val="1050087441"/>
                    </a:ext>
                  </a:extLst>
                </a:gridCol>
                <a:gridCol w="345488">
                  <a:extLst>
                    <a:ext uri="{9D8B030D-6E8A-4147-A177-3AD203B41FA5}">
                      <a16:colId xmlns:a16="http://schemas.microsoft.com/office/drawing/2014/main" val="3837723205"/>
                    </a:ext>
                  </a:extLst>
                </a:gridCol>
                <a:gridCol w="345488">
                  <a:extLst>
                    <a:ext uri="{9D8B030D-6E8A-4147-A177-3AD203B41FA5}">
                      <a16:colId xmlns:a16="http://schemas.microsoft.com/office/drawing/2014/main" val="1546875001"/>
                    </a:ext>
                  </a:extLst>
                </a:gridCol>
                <a:gridCol w="345488">
                  <a:extLst>
                    <a:ext uri="{9D8B030D-6E8A-4147-A177-3AD203B41FA5}">
                      <a16:colId xmlns:a16="http://schemas.microsoft.com/office/drawing/2014/main" val="2599196798"/>
                    </a:ext>
                  </a:extLst>
                </a:gridCol>
                <a:gridCol w="345488">
                  <a:extLst>
                    <a:ext uri="{9D8B030D-6E8A-4147-A177-3AD203B41FA5}">
                      <a16:colId xmlns:a16="http://schemas.microsoft.com/office/drawing/2014/main" val="417848447"/>
                    </a:ext>
                  </a:extLst>
                </a:gridCol>
                <a:gridCol w="607364">
                  <a:extLst>
                    <a:ext uri="{9D8B030D-6E8A-4147-A177-3AD203B41FA5}">
                      <a16:colId xmlns:a16="http://schemas.microsoft.com/office/drawing/2014/main" val="976727296"/>
                    </a:ext>
                  </a:extLst>
                </a:gridCol>
                <a:gridCol w="607364">
                  <a:extLst>
                    <a:ext uri="{9D8B030D-6E8A-4147-A177-3AD203B41FA5}">
                      <a16:colId xmlns:a16="http://schemas.microsoft.com/office/drawing/2014/main" val="1413348495"/>
                    </a:ext>
                  </a:extLst>
                </a:gridCol>
                <a:gridCol w="607364">
                  <a:extLst>
                    <a:ext uri="{9D8B030D-6E8A-4147-A177-3AD203B41FA5}">
                      <a16:colId xmlns:a16="http://schemas.microsoft.com/office/drawing/2014/main" val="3093624290"/>
                    </a:ext>
                  </a:extLst>
                </a:gridCol>
                <a:gridCol w="607364">
                  <a:extLst>
                    <a:ext uri="{9D8B030D-6E8A-4147-A177-3AD203B41FA5}">
                      <a16:colId xmlns:a16="http://schemas.microsoft.com/office/drawing/2014/main" val="491825309"/>
                    </a:ext>
                  </a:extLst>
                </a:gridCol>
                <a:gridCol w="607364">
                  <a:extLst>
                    <a:ext uri="{9D8B030D-6E8A-4147-A177-3AD203B41FA5}">
                      <a16:colId xmlns:a16="http://schemas.microsoft.com/office/drawing/2014/main" val="1501224028"/>
                    </a:ext>
                  </a:extLst>
                </a:gridCol>
                <a:gridCol w="607364">
                  <a:extLst>
                    <a:ext uri="{9D8B030D-6E8A-4147-A177-3AD203B41FA5}">
                      <a16:colId xmlns:a16="http://schemas.microsoft.com/office/drawing/2014/main" val="2799324255"/>
                    </a:ext>
                  </a:extLst>
                </a:gridCol>
                <a:gridCol w="607364">
                  <a:extLst>
                    <a:ext uri="{9D8B030D-6E8A-4147-A177-3AD203B41FA5}">
                      <a16:colId xmlns:a16="http://schemas.microsoft.com/office/drawing/2014/main" val="1284193227"/>
                    </a:ext>
                  </a:extLst>
                </a:gridCol>
              </a:tblGrid>
              <a:tr h="241628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Table S1. Chloroplast haplotype of each population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9406528"/>
                  </a:ext>
                </a:extLst>
              </a:tr>
              <a:tr h="241628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ulation ID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N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Hap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Hap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Hap3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Hap4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Hap5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Hap6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Hap7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Hap8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Hap9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Hap10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8548491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3713352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5/6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6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8180915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3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5/5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074365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4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1411517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5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5464419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6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4/15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15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0587958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7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372458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8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7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6/7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7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1728117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9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8762036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10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6356490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1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8, 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5/8, 1/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8, 1/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8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8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6155047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1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3/4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4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009626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13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8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8/8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5184281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14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4/6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6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6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6107596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15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5/5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0904898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16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9970249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17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1/1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8432282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18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2/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7909024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19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2/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4705408"/>
                  </a:ext>
                </a:extLst>
              </a:tr>
              <a:tr h="166167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Pop20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2/2</a:t>
                      </a: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3658" marR="3658" marT="365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67134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19724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321</Words>
  <Application>Microsoft Office PowerPoint</Application>
  <PresentationFormat>A4 210 x 297 mm</PresentationFormat>
  <Paragraphs>98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3" baseType="lpstr">
      <vt:lpstr>Liberation Serif</vt:lpstr>
      <vt:lpstr>游ゴシック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1 R</dc:creator>
  <cp:lastModifiedBy>1 R</cp:lastModifiedBy>
  <cp:revision>7</cp:revision>
  <dcterms:created xsi:type="dcterms:W3CDTF">2020-02-03T01:44:25Z</dcterms:created>
  <dcterms:modified xsi:type="dcterms:W3CDTF">2021-09-16T03:24:53Z</dcterms:modified>
</cp:coreProperties>
</file>